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723F477-3EAA-4A29-9BBA-F029C34960B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792AAD2-6318-4480-9B11-3A85356BA0A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F6DB9-8131-497C-8BF3-69A46AE24D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10E7D-89F0-4E18-B9A5-CDEAE9587C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2C68C9-0D9D-42FF-A271-6BA019A08B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04E76B-20AB-4C17-B79D-B72A12A8E4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3E4B4-8EEC-4DA3-A76E-AEA9CCA037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028DCE-0A4B-454D-AC8D-EF8120C57F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65608-B3CD-4599-951F-BBB1393330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5714E-3DD3-4D5C-A630-4208A2E5CE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B4650-2483-4233-A3BE-A74E63ADBB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C9B25-BA60-435E-8329-FA227D0CE2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644E1-AF11-4C15-A1AE-05385838E9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C57437-C7BC-4F1F-A41E-C526D5A02A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F88928F-8891-4BFF-9E3A-2989316D513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307800" y="382680"/>
            <a:ext cx="4583160" cy="4330440"/>
          </a:xfrm>
          <a:prstGeom prst="rect">
            <a:avLst/>
          </a:prstGeom>
          <a:ln w="0">
            <a:noFill/>
          </a:ln>
        </p:spPr>
      </p:pic>
      <p:sp>
        <p:nvSpPr>
          <p:cNvPr id="49" name="TextBox 9"/>
          <p:cNvSpPr/>
          <p:nvPr/>
        </p:nvSpPr>
        <p:spPr>
          <a:xfrm>
            <a:off x="0" y="274680"/>
            <a:ext cx="493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"/>
          <p:cNvSpPr/>
          <p:nvPr/>
        </p:nvSpPr>
        <p:spPr>
          <a:xfrm>
            <a:off x="0" y="4713120"/>
            <a:ext cx="4676760" cy="179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Bortezomib Titration in 0989 and 090 Cells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A,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 089 and 090 cells were treated with increasing concentrations of Bortezomib of up to 10 ng/ml for 48 hours before MTT analysis. Results represent mean cell viability normalised to untreated control cells, error bars indicate SEM (N = 3)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17T16:22:47Z</dcterms:created>
  <dc:creator>Jessica Bullenkamp</dc:creator>
  <dc:description/>
  <dc:language>en-US</dc:language>
  <cp:lastModifiedBy>mn.nandini</cp:lastModifiedBy>
  <dcterms:modified xsi:type="dcterms:W3CDTF">2014-10-16T09:16:50Z</dcterms:modified>
  <cp:revision>5</cp:revision>
  <dc:subject/>
  <dc:title>PowerPoint Presentation</dc:title>
</cp:coreProperties>
</file>